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2" d="100"/>
          <a:sy n="82" d="100"/>
        </p:scale>
        <p:origin x="1408" y="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517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3947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5081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9605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3280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7909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0439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6070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6270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5003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8384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97688-A447-4DE9-9EFA-D15F18B9E64E}" type="datetimeFigureOut">
              <a:rPr lang="de-DE" smtClean="0"/>
              <a:t>29.10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71FB5-CC3B-4C3F-8ADF-70268D28E6C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9371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sp>
        <p:nvSpPr>
          <p:cNvPr id="6" name="Textfeld 5"/>
          <p:cNvSpPr txBox="1"/>
          <p:nvPr/>
        </p:nvSpPr>
        <p:spPr>
          <a:xfrm>
            <a:off x="116632" y="107504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188640" y="39553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3536584" y="46754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1FB419C1-F6FA-4FC5-8715-C690EF42D0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49" y="672535"/>
            <a:ext cx="3311835" cy="1512000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31B56DBA-FC99-40D7-8C1A-185184B75A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9797" y="672535"/>
            <a:ext cx="3365419" cy="1512000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216C1FC0-66C8-4F81-9F54-56B3F9850BA2}"/>
              </a:ext>
            </a:extLst>
          </p:cNvPr>
          <p:cNvSpPr txBox="1"/>
          <p:nvPr/>
        </p:nvSpPr>
        <p:spPr>
          <a:xfrm>
            <a:off x="227837" y="2251026"/>
            <a:ext cx="69127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i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rst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hogen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ion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s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hogen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s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II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hogen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</a:t>
            </a:r>
          </a:p>
        </p:txBody>
      </p:sp>
    </p:spTree>
    <p:extLst>
      <p:ext uri="{BB962C8B-B14F-4D97-AF65-F5344CB8AC3E}">
        <p14:creationId xmlns:p14="http://schemas.microsoft.com/office/powerpoint/2010/main" val="1704060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sp>
        <p:nvSpPr>
          <p:cNvPr id="6" name="Textfeld 5"/>
          <p:cNvSpPr txBox="1"/>
          <p:nvPr/>
        </p:nvSpPr>
        <p:spPr>
          <a:xfrm>
            <a:off x="116632" y="107504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A7AB1F49-F09B-4566-9089-4F22645916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73358"/>
            <a:ext cx="3336585" cy="1800000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1475D14B-8CF7-48C3-B724-3F749CF14250}"/>
              </a:ext>
            </a:extLst>
          </p:cNvPr>
          <p:cNvSpPr txBox="1"/>
          <p:nvPr/>
        </p:nvSpPr>
        <p:spPr>
          <a:xfrm>
            <a:off x="227837" y="2251026"/>
            <a:ext cx="69127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hogen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s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hogens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463127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Bildschirmpräsentation (4:3)</PresentationFormat>
  <Paragraphs>6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Larissa</vt:lpstr>
      <vt:lpstr>PowerPoint-Präsentation</vt:lpstr>
      <vt:lpstr>PowerPoint-Präsentation</vt:lpstr>
    </vt:vector>
  </TitlesOfParts>
  <Company>UK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Natascha Köstlin-Gille</dc:creator>
  <cp:lastModifiedBy>Dr. Natascha Köstlin-Gille</cp:lastModifiedBy>
  <cp:revision>7</cp:revision>
  <dcterms:created xsi:type="dcterms:W3CDTF">2021-01-03T15:58:41Z</dcterms:created>
  <dcterms:modified xsi:type="dcterms:W3CDTF">2021-10-29T12:53:37Z</dcterms:modified>
</cp:coreProperties>
</file>